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DC48F0-3C4B-4D47-97B6-8D5DF23946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6C9631-5095-45B2-A61C-0EBC7E27F0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8CF3B6-3147-4865-9AC5-36772EE9D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F631F0-7FA2-48D4-86B0-64AAC7E29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0EB503-475C-45F3-804E-CAFD7F882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87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3106C4-6B07-4A38-B2FE-4767F7EA1A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41E7FC-5521-4C34-A554-7539FF4ED7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8B6524-3DC8-4F5D-A515-71B2D3497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1EC269-E4EA-4713-98A4-F4DD5E0B9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730F1B-EA47-4BA4-87A0-BB812A1F0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2460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4D3D321-A6C6-43C6-BD05-549E98058E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D9BE88-D326-481F-B231-6622B5F3A4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5D7789-7024-4F66-BFD0-773FCFAC3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612AA7-2DE7-4BD3-A3AD-CAAD9F105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5AC9F7-8265-41A6-A792-4B57E36C0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5536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974331-8104-42A6-9903-0739ED576A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E87A3C-7380-4BA3-A12D-DE14123F35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9EC4C6-4750-42F0-A526-C78315009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284845-362E-4443-87A2-1A7FDE10E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85754A-A4D1-4EE9-8B4F-FD154E693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284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ACD1B-4D98-4002-BE9E-4DE58C9D6C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B492B4-AC88-400E-86C4-2852953E7B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5CCC90-5EC9-43E4-93F8-E3EE367DB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965320-76F3-4BAE-9386-879B04EC6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AADBF1-28AD-4752-9928-485E2BF85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945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094641-A97F-4862-B844-67C08DE1CE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D6EBC5-DB06-47CB-AD6D-2E2FA76D56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E46992-A7B0-418B-B127-A02C347531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0AA396-880E-40DF-884E-DA2520228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F7EEE5-BDDF-4B22-AE8D-98CC89E37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832C4E-8CCB-490F-A5F6-241494C583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24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43A06A-8959-4A64-B1A4-0649CDF265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82161F-6A8E-484C-9B99-9B611BDDB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608787-BD0F-4001-BD75-A6E9233001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CA4C69-5D1E-4DCE-A2D9-C97505AD9B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5B08AA-E274-4A7C-9A40-85F504C920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309D5E-91C1-40D4-B843-42986EC81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4E2486B-6C5E-4174-86A8-C28F92B39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8EFEC8-168F-4553-9A42-F0671A915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701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5AF3A2-FA30-479B-BE1C-AE65552C62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338643-FF1C-4DEF-AB97-812B88C87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DBDBCD-562B-41BB-A3EF-A72F995663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81FCA5D-D3AB-4CE9-ACE2-E1574592F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259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80B768-E01C-44F6-8FA8-00B03F3AF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5EF4F1B-9446-4540-A566-4AEE2664F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779E15-16C8-485B-BF54-09AA54F67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223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EE5FE-37CB-47A2-94DF-D45D2EB56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AD5ED2-174A-4C53-A136-FD486936F0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BA3359-770D-43C8-9993-2A6A9E7166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BBFA3E-4290-4A16-98AD-57E08E486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EAA549-AADF-4AC3-B6E5-516DD4B95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BBD331-E2EB-452C-8E8B-7F99853B9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104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BED3D-A448-4C48-B2BB-91AA2A28C2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B724C2-1FD6-4607-BBF6-F73F0CF664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88AB8A-EFF7-45A0-AF7B-8C3405B393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F00682-CE2A-4CFD-AE79-513C5E71D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323904-A2B0-4836-B05F-76B5302B4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CF15CE-6B1F-4912-8592-3E418D55E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046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E6F672-A8BD-4EC0-9324-35F3C2EBE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D7471C-0A79-42CB-8C6E-1ABA613888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B9561-CE93-4254-AAD3-3DE38416B6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E1F0F-DCC0-4A60-8B61-286CA1F3D0F6}" type="datetimeFigureOut">
              <a:rPr lang="en-US" smtClean="0"/>
              <a:t>5/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DD35DD-EF45-44F6-AB64-A91B39D1B7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A71798-1C99-4B9E-9FEA-441450AEE82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6CB1C-3AB2-486A-8C37-E25FFC55B9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E200853-060D-4BA2-972B-1944663BB8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4944" y="1278954"/>
            <a:ext cx="3602682" cy="2765379"/>
          </a:xfrm>
          <a:prstGeom prst="rect">
            <a:avLst/>
          </a:prstGeom>
        </p:spPr>
      </p:pic>
      <p:pic>
        <p:nvPicPr>
          <p:cNvPr id="5" name="Picture 71" descr="C:\Users\pyang\AppData\Local\Temp\SNAGHTML96f553.PNG">
            <a:extLst>
              <a:ext uri="{FF2B5EF4-FFF2-40B4-BE49-F238E27FC236}">
                <a16:creationId xmlns:a16="http://schemas.microsoft.com/office/drawing/2014/main" id="{DC3425FF-D2FD-40B1-A88C-B7A3419DECB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117" y="1507305"/>
            <a:ext cx="4089454" cy="24961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6E16E02-AE10-44D6-94C7-202DD470ECD8}"/>
              </a:ext>
            </a:extLst>
          </p:cNvPr>
          <p:cNvSpPr txBox="1"/>
          <p:nvPr/>
        </p:nvSpPr>
        <p:spPr>
          <a:xfrm>
            <a:off x="1351634" y="4300365"/>
            <a:ext cx="9070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. The expression of CD133 (</a:t>
            </a:r>
            <a:r>
              <a:rPr lang="en-US" b="1" i="1" dirty="0"/>
              <a:t>A</a:t>
            </a:r>
            <a:r>
              <a:rPr lang="en-US" dirty="0"/>
              <a:t>) and Met (</a:t>
            </a:r>
            <a:r>
              <a:rPr lang="en-US" b="1" i="1" dirty="0"/>
              <a:t>B</a:t>
            </a:r>
            <a:r>
              <a:rPr lang="en-US" dirty="0"/>
              <a:t>) protein in Panc-1 tumor tissues treated with Fraction B (6 mg/kg)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7BBB7E-8980-46FA-A48B-62944FA24D07}"/>
              </a:ext>
            </a:extLst>
          </p:cNvPr>
          <p:cNvSpPr txBox="1"/>
          <p:nvPr/>
        </p:nvSpPr>
        <p:spPr>
          <a:xfrm>
            <a:off x="1492175" y="1186101"/>
            <a:ext cx="38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56C767-1677-47DF-B6A5-FC45104651D2}"/>
              </a:ext>
            </a:extLst>
          </p:cNvPr>
          <p:cNvSpPr txBox="1"/>
          <p:nvPr/>
        </p:nvSpPr>
        <p:spPr>
          <a:xfrm>
            <a:off x="5302178" y="1338501"/>
            <a:ext cx="38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4620037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9B88A78-7873-41E8-8847-87BC9ED9B45E}"/>
              </a:ext>
            </a:extLst>
          </p:cNvPr>
          <p:cNvSpPr/>
          <p:nvPr/>
        </p:nvSpPr>
        <p:spPr>
          <a:xfrm>
            <a:off x="2020824" y="4747079"/>
            <a:ext cx="8467344" cy="368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2. Terminal body weight of mice bearing Panc-1 tumor treated with Fraction B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1AF3A96-BB4B-4ACC-B969-0E0545556C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014225"/>
              </p:ext>
            </p:extLst>
          </p:nvPr>
        </p:nvGraphicFramePr>
        <p:xfrm>
          <a:off x="4019995" y="799275"/>
          <a:ext cx="2234501" cy="39478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1919523" imgH="3390850" progId="Prism8.Document">
                  <p:embed/>
                </p:oleObj>
              </mc:Choice>
              <mc:Fallback>
                <p:oleObj name="Prism 8" r:id="rId3" imgW="1919523" imgH="3390850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BCC4FCE7-E357-439C-8F95-B068C40EA8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019995" y="799275"/>
                        <a:ext cx="2234501" cy="39478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06639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7</Words>
  <Application>Microsoft Office PowerPoint</Application>
  <PresentationFormat>Widescreen</PresentationFormat>
  <Paragraphs>4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,Peiying</dc:creator>
  <cp:lastModifiedBy>Yang,Peiying</cp:lastModifiedBy>
  <cp:revision>1</cp:revision>
  <dcterms:created xsi:type="dcterms:W3CDTF">2021-05-08T17:24:05Z</dcterms:created>
  <dcterms:modified xsi:type="dcterms:W3CDTF">2021-05-08T17:25:18Z</dcterms:modified>
</cp:coreProperties>
</file>